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94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C8853-F256-E989-5D2D-97A28DD82F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059861-8426-62EE-CD8A-F1EF47936E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5A84DD-3FA4-D9BD-36DF-CB10C39D7D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84CCD7-EDB0-E9D4-28AB-88087B705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8807E7-8918-E830-F8FF-3ED32D6F1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78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8A59AE-73D3-F605-1CD9-F389C2955B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3A0728-56E7-62D9-E683-028441F5EF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7EE93C-DCE2-67BC-3CCB-021586BD9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0CF96-D905-4DDA-F0AA-6339B9FC6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CB0316-A869-59A5-0788-CB6A86714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046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DBC5661-E6C3-7AD2-BBB3-8A7C4CE708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F63729-A42F-6830-28AC-93F1CF11CD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C5DBFB-7C87-958C-0E59-C428BD4A7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31DDD0-69AF-AA2B-6928-D3CAEBE22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82C66D-3E30-9E28-0C3A-966B2AB5D6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909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E24CB4-7351-A379-D004-B8789EF7B1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B4D405-5234-3F9A-20CB-9FF2F8ED7F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C8AE28-65D7-74DE-6B02-8EA9EEF45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CD2A8-5F1D-BFC7-0053-F74E1C134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B008D-D939-2489-537D-ADAB0DAF7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427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F2F158-36B9-ED68-9469-28C9CA36D9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E80EC1-8A98-C0D8-3A97-D0965D66CF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5FE7B7-6509-20B5-570D-DAF3F14E2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213724-0B9B-2653-6531-12A200245B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214ACA-B5D0-8E3B-2B18-8B744B66D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355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63209-1E53-619E-7EB1-38931D165A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7D5851-0B37-2916-AC7C-2DAE435595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FF799-3A60-4D4A-DB8D-192D5F7766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F5826E-3E9E-23E5-569D-FB7022CEA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995AEA-0D7A-54DF-D313-0044B2CB8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77E03D-CB2C-944B-434D-530BEEEE3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93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C9DFE-6FF4-5D00-014F-EC9771A2E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C39274-1E3B-DC29-94C8-5AA201F9DE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C308BE-C2E6-ACF8-98A6-8664AAA80D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195B253-EBA7-EA68-7DEB-7DB51F4D8D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627C57-A437-4BE4-71F0-BC0209D7A7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E44172E-3F4D-037E-4B32-EEC213456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103558-FF54-8D91-F037-DC7E6FE33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47FC3C-0606-2FC8-5E3C-E18A7BD8B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066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E2A2E-CA26-895D-36E5-B4AA3AA8C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6074EC-BD72-D2CE-022C-2657DCF7A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2C4649-BBBF-28FC-5B31-06A3CA7B4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3A1125-F42E-E745-0CA1-80C7935B7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193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07BFBE-82AD-B96E-08AE-822085BC7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A2A75EC-4E64-1E99-830F-9728782C07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5760B6-E1B9-61D1-6548-970A4B3A6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89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6EADA4-81BD-5767-7BC2-96FA8B0010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E14666-A23A-67DF-AEE3-6B3DE9B345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F7CD73-1789-8158-7DCF-396C803FE2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9BC8E3-414E-722B-FC06-688CCDD78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F1B918-A2E2-6535-4E03-9BD60773B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28FDEC-7C2D-6506-EEF4-96BF3993A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666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EC7AA-2C88-32F2-EBED-F625EA693B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D4A456-E821-E0CB-464F-D83C2E5666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2F2670-3667-AC16-91BF-1B99B2E592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5F1CCC-32B4-0E90-0ED6-EBF939FF2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038219-5903-A656-43D8-6AB8E7251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F2E4E2-E925-CF8D-7CD8-B5400E0EF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654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F442D7-64F8-1102-A78B-4F61CA027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17B98B-47F6-BFA4-CFCE-372879625B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F82A7E-6AB8-86CF-E88B-58D81B33F7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D0783-6707-4CB8-BC8F-379B119687D2}" type="datetimeFigureOut">
              <a:rPr lang="en-US" smtClean="0"/>
              <a:t>1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5F4A4D-565D-9A7F-5830-251CFC9073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ACD55F-046B-9831-2363-0DC2CF25DE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FE9A4-CB17-4E3E-B47C-D14206ABC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535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2.tif"/><Relationship Id="rId7" Type="http://schemas.openxmlformats.org/officeDocument/2006/relationships/image" Target="../media/image5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10" Type="http://schemas.microsoft.com/office/2007/relationships/hdphoto" Target="../media/hdphoto2.wdp"/><Relationship Id="rId4" Type="http://schemas.openxmlformats.org/officeDocument/2006/relationships/image" Target="../media/image3.ti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380D9CD-B617-4881-90BB-48BE57FF7229}"/>
              </a:ext>
            </a:extLst>
          </p:cNvPr>
          <p:cNvSpPr txBox="1"/>
          <p:nvPr/>
        </p:nvSpPr>
        <p:spPr>
          <a:xfrm>
            <a:off x="449377" y="6400244"/>
            <a:ext cx="499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LR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下游基因、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B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pc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4">
            <a:extLst>
              <a:ext uri="{FF2B5EF4-FFF2-40B4-BE49-F238E27FC236}">
                <a16:creationId xmlns:a16="http://schemas.microsoft.com/office/drawing/2014/main" id="{089AE7A0-805D-AF17-CAD5-CB1C3B6F2AF7}"/>
              </a:ext>
            </a:extLst>
          </p:cNvPr>
          <p:cNvSpPr txBox="1"/>
          <p:nvPr/>
        </p:nvSpPr>
        <p:spPr>
          <a:xfrm>
            <a:off x="645665" y="1987712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pdcd4</a:t>
            </a:r>
            <a:endParaRPr kumimoji="1" lang="zh-CN" altLang="en-US" dirty="0">
              <a:latin typeface="Arial" panose="020B0604020202020204" pitchFamily="34" charset="0"/>
              <a:ea typeface="Microsoft YaHei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矩形 20">
            <a:extLst>
              <a:ext uri="{FF2B5EF4-FFF2-40B4-BE49-F238E27FC236}">
                <a16:creationId xmlns:a16="http://schemas.microsoft.com/office/drawing/2014/main" id="{C8856085-6C61-EB89-4624-A33A54521BD5}"/>
              </a:ext>
            </a:extLst>
          </p:cNvPr>
          <p:cNvSpPr/>
          <p:nvPr/>
        </p:nvSpPr>
        <p:spPr>
          <a:xfrm>
            <a:off x="695837" y="4825404"/>
            <a:ext cx="787395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Puma</a:t>
            </a:r>
          </a:p>
        </p:txBody>
      </p:sp>
      <p:sp>
        <p:nvSpPr>
          <p:cNvPr id="23" name="矩形 21">
            <a:extLst>
              <a:ext uri="{FF2B5EF4-FFF2-40B4-BE49-F238E27FC236}">
                <a16:creationId xmlns:a16="http://schemas.microsoft.com/office/drawing/2014/main" id="{B756CFEF-BA4B-CDB5-D98F-72B01CF38FD0}"/>
              </a:ext>
            </a:extLst>
          </p:cNvPr>
          <p:cNvSpPr/>
          <p:nvPr/>
        </p:nvSpPr>
        <p:spPr>
          <a:xfrm>
            <a:off x="449377" y="1354861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TP53INP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9409FC76-497E-124C-F8BF-5E6C6E2A0509}"/>
              </a:ext>
            </a:extLst>
          </p:cNvPr>
          <p:cNvSpPr/>
          <p:nvPr/>
        </p:nvSpPr>
        <p:spPr>
          <a:xfrm>
            <a:off x="840412" y="3423174"/>
            <a:ext cx="582211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 err="1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ax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D680AB5A-4F7D-0BC0-FD2C-AC9008574493}"/>
              </a:ext>
            </a:extLst>
          </p:cNvPr>
          <p:cNvSpPr/>
          <p:nvPr/>
        </p:nvSpPr>
        <p:spPr>
          <a:xfrm>
            <a:off x="841944" y="4088182"/>
            <a:ext cx="595035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ad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1C78D5A-3FC7-85F0-C449-5098F29D0C45}"/>
              </a:ext>
            </a:extLst>
          </p:cNvPr>
          <p:cNvSpPr txBox="1"/>
          <p:nvPr/>
        </p:nvSpPr>
        <p:spPr>
          <a:xfrm>
            <a:off x="690495" y="534732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促凋亡</a:t>
            </a:r>
          </a:p>
        </p:txBody>
      </p:sp>
      <p:sp>
        <p:nvSpPr>
          <p:cNvPr id="27" name="矩形 100">
            <a:extLst>
              <a:ext uri="{FF2B5EF4-FFF2-40B4-BE49-F238E27FC236}">
                <a16:creationId xmlns:a16="http://schemas.microsoft.com/office/drawing/2014/main" id="{CE799C91-8614-9606-B04A-49FE2BDBA288}"/>
              </a:ext>
            </a:extLst>
          </p:cNvPr>
          <p:cNvSpPr/>
          <p:nvPr/>
        </p:nvSpPr>
        <p:spPr>
          <a:xfrm>
            <a:off x="224033" y="2716584"/>
            <a:ext cx="141577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C-caspase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13">
            <a:extLst>
              <a:ext uri="{FF2B5EF4-FFF2-40B4-BE49-F238E27FC236}">
                <a16:creationId xmlns:a16="http://schemas.microsoft.com/office/drawing/2014/main" id="{2E64638A-B788-905C-8B43-28DD771E9CBD}"/>
              </a:ext>
            </a:extLst>
          </p:cNvPr>
          <p:cNvSpPr/>
          <p:nvPr/>
        </p:nvSpPr>
        <p:spPr>
          <a:xfrm>
            <a:off x="2677814" y="4411630"/>
            <a:ext cx="671979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Mcl1</a:t>
            </a:r>
          </a:p>
        </p:txBody>
      </p:sp>
      <p:sp>
        <p:nvSpPr>
          <p:cNvPr id="29" name="矩形 18">
            <a:extLst>
              <a:ext uri="{FF2B5EF4-FFF2-40B4-BE49-F238E27FC236}">
                <a16:creationId xmlns:a16="http://schemas.microsoft.com/office/drawing/2014/main" id="{A769B9BE-A500-A281-D50A-69FC66667B9D}"/>
              </a:ext>
            </a:extLst>
          </p:cNvPr>
          <p:cNvSpPr/>
          <p:nvPr/>
        </p:nvSpPr>
        <p:spPr>
          <a:xfrm>
            <a:off x="2656276" y="3766360"/>
            <a:ext cx="748923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 err="1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cl</a:t>
            </a:r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-xl</a:t>
            </a:r>
          </a:p>
        </p:txBody>
      </p:sp>
      <p:sp>
        <p:nvSpPr>
          <p:cNvPr id="30" name="矩形 19">
            <a:extLst>
              <a:ext uri="{FF2B5EF4-FFF2-40B4-BE49-F238E27FC236}">
                <a16:creationId xmlns:a16="http://schemas.microsoft.com/office/drawing/2014/main" id="{42759D4A-74D7-AE0F-B018-61EE5318FE75}"/>
              </a:ext>
            </a:extLst>
          </p:cNvPr>
          <p:cNvSpPr/>
          <p:nvPr/>
        </p:nvSpPr>
        <p:spPr>
          <a:xfrm>
            <a:off x="2707694" y="3137248"/>
            <a:ext cx="710451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cl-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26">
            <a:extLst>
              <a:ext uri="{FF2B5EF4-FFF2-40B4-BE49-F238E27FC236}">
                <a16:creationId xmlns:a16="http://schemas.microsoft.com/office/drawing/2014/main" id="{5967B8BF-AB23-63CA-1D59-BA6F890955F2}"/>
              </a:ext>
            </a:extLst>
          </p:cNvPr>
          <p:cNvSpPr txBox="1"/>
          <p:nvPr/>
        </p:nvSpPr>
        <p:spPr>
          <a:xfrm>
            <a:off x="2619666" y="5194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抑制凋亡</a:t>
            </a:r>
          </a:p>
        </p:txBody>
      </p:sp>
      <p:sp>
        <p:nvSpPr>
          <p:cNvPr id="32" name="矩形 14">
            <a:extLst>
              <a:ext uri="{FF2B5EF4-FFF2-40B4-BE49-F238E27FC236}">
                <a16:creationId xmlns:a16="http://schemas.microsoft.com/office/drawing/2014/main" id="{D864D947-7872-9E14-EDC7-0279F083E2D2}"/>
              </a:ext>
            </a:extLst>
          </p:cNvPr>
          <p:cNvSpPr/>
          <p:nvPr/>
        </p:nvSpPr>
        <p:spPr>
          <a:xfrm>
            <a:off x="2782901" y="469968"/>
            <a:ext cx="710451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irc3</a:t>
            </a:r>
          </a:p>
        </p:txBody>
      </p:sp>
      <p:sp>
        <p:nvSpPr>
          <p:cNvPr id="33" name="矩形 15">
            <a:extLst>
              <a:ext uri="{FF2B5EF4-FFF2-40B4-BE49-F238E27FC236}">
                <a16:creationId xmlns:a16="http://schemas.microsoft.com/office/drawing/2014/main" id="{410D3F98-32D2-4D7A-E06F-E18E3DB6F01F}"/>
              </a:ext>
            </a:extLst>
          </p:cNvPr>
          <p:cNvSpPr/>
          <p:nvPr/>
        </p:nvSpPr>
        <p:spPr>
          <a:xfrm>
            <a:off x="2707927" y="2643199"/>
            <a:ext cx="479618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fli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17">
            <a:extLst>
              <a:ext uri="{FF2B5EF4-FFF2-40B4-BE49-F238E27FC236}">
                <a16:creationId xmlns:a16="http://schemas.microsoft.com/office/drawing/2014/main" id="{3F54C648-E45B-FE1C-6A11-700B920BF141}"/>
              </a:ext>
            </a:extLst>
          </p:cNvPr>
          <p:cNvSpPr/>
          <p:nvPr/>
        </p:nvSpPr>
        <p:spPr>
          <a:xfrm>
            <a:off x="2753494" y="1202117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Bcl2A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22">
            <a:extLst>
              <a:ext uri="{FF2B5EF4-FFF2-40B4-BE49-F238E27FC236}">
                <a16:creationId xmlns:a16="http://schemas.microsoft.com/office/drawing/2014/main" id="{0E334132-8029-80B7-BEE2-E4B99C6C8D18}"/>
              </a:ext>
            </a:extLst>
          </p:cNvPr>
          <p:cNvSpPr/>
          <p:nvPr/>
        </p:nvSpPr>
        <p:spPr>
          <a:xfrm>
            <a:off x="2745287" y="2041532"/>
            <a:ext cx="1120884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TNFAIP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16">
            <a:extLst>
              <a:ext uri="{FF2B5EF4-FFF2-40B4-BE49-F238E27FC236}">
                <a16:creationId xmlns:a16="http://schemas.microsoft.com/office/drawing/2014/main" id="{61C4A36B-78B5-765D-81EF-F20BE176B9BE}"/>
              </a:ext>
            </a:extLst>
          </p:cNvPr>
          <p:cNvSpPr txBox="1"/>
          <p:nvPr/>
        </p:nvSpPr>
        <p:spPr>
          <a:xfrm>
            <a:off x="252681" y="247992"/>
            <a:ext cx="1604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210818</a:t>
            </a:r>
            <a:r>
              <a:rPr kumimoji="1" lang="zh-CN" altLang="en-US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5%</a:t>
            </a:r>
            <a:r>
              <a:rPr kumimoji="1" lang="zh-CN" altLang="en-US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3" name="文本框 16">
            <a:extLst>
              <a:ext uri="{FF2B5EF4-FFF2-40B4-BE49-F238E27FC236}">
                <a16:creationId xmlns:a16="http://schemas.microsoft.com/office/drawing/2014/main" id="{6B7B053C-22F1-456C-D3A1-77053147E260}"/>
              </a:ext>
            </a:extLst>
          </p:cNvPr>
          <p:cNvSpPr txBox="1"/>
          <p:nvPr/>
        </p:nvSpPr>
        <p:spPr>
          <a:xfrm>
            <a:off x="247984" y="701144"/>
            <a:ext cx="1604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210820</a:t>
            </a:r>
            <a:r>
              <a:rPr kumimoji="1" lang="zh-CN" altLang="en-US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  <a:r>
              <a:rPr kumimoji="1" lang="en-US" altLang="zh-CN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15%</a:t>
            </a:r>
            <a:r>
              <a:rPr kumimoji="1" lang="zh-CN" altLang="en-US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57" name="Group 56">
            <a:extLst>
              <a:ext uri="{FF2B5EF4-FFF2-40B4-BE49-F238E27FC236}">
                <a16:creationId xmlns:a16="http://schemas.microsoft.com/office/drawing/2014/main" id="{68A3EAC2-4304-1699-3EE0-273CFC9E0674}"/>
              </a:ext>
            </a:extLst>
          </p:cNvPr>
          <p:cNvGrpSpPr/>
          <p:nvPr/>
        </p:nvGrpSpPr>
        <p:grpSpPr>
          <a:xfrm>
            <a:off x="3463063" y="1070476"/>
            <a:ext cx="8982937" cy="4941597"/>
            <a:chOff x="6113122" y="1164690"/>
            <a:chExt cx="8982937" cy="4941597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FFAABF3-FB5F-92D4-2ED2-9ED4D1CC6234}"/>
                </a:ext>
              </a:extLst>
            </p:cNvPr>
            <p:cNvSpPr txBox="1"/>
            <p:nvPr/>
          </p:nvSpPr>
          <p:spPr>
            <a:xfrm>
              <a:off x="8638625" y="1164690"/>
              <a:ext cx="10107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aDu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EEBEFE3-8320-F5EA-8186-133225DA400B}"/>
                </a:ext>
              </a:extLst>
            </p:cNvPr>
            <p:cNvGrpSpPr/>
            <p:nvPr/>
          </p:nvGrpSpPr>
          <p:grpSpPr>
            <a:xfrm>
              <a:off x="6113122" y="1518572"/>
              <a:ext cx="8982937" cy="4587715"/>
              <a:chOff x="6113122" y="1518572"/>
              <a:chExt cx="8982937" cy="4587715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FB92D5C2-513A-E243-1D69-E857509DFDEA}"/>
                  </a:ext>
                </a:extLst>
              </p:cNvPr>
              <p:cNvGrpSpPr/>
              <p:nvPr/>
            </p:nvGrpSpPr>
            <p:grpSpPr>
              <a:xfrm>
                <a:off x="6113122" y="1518572"/>
                <a:ext cx="8982937" cy="4587715"/>
                <a:chOff x="6091823" y="1533267"/>
                <a:chExt cx="8982937" cy="4587715"/>
              </a:xfrm>
            </p:grpSpPr>
            <p:sp>
              <p:nvSpPr>
                <p:cNvPr id="3" name="文本框 24">
                  <a:extLst>
                    <a:ext uri="{FF2B5EF4-FFF2-40B4-BE49-F238E27FC236}">
                      <a16:creationId xmlns:a16="http://schemas.microsoft.com/office/drawing/2014/main" id="{17318D03-40C8-402A-9D7B-3A0966F15ADA}"/>
                    </a:ext>
                  </a:extLst>
                </p:cNvPr>
                <p:cNvSpPr txBox="1"/>
                <p:nvPr/>
              </p:nvSpPr>
              <p:spPr>
                <a:xfrm>
                  <a:off x="10296290" y="2872102"/>
                  <a:ext cx="96693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PDCD4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矩形 21">
                  <a:extLst>
                    <a:ext uri="{FF2B5EF4-FFF2-40B4-BE49-F238E27FC236}">
                      <a16:creationId xmlns:a16="http://schemas.microsoft.com/office/drawing/2014/main" id="{A7F445F5-A902-4EFF-B7A8-660C597A8BCD}"/>
                    </a:ext>
                  </a:extLst>
                </p:cNvPr>
                <p:cNvSpPr/>
                <p:nvPr/>
              </p:nvSpPr>
              <p:spPr>
                <a:xfrm>
                  <a:off x="10296290" y="2448377"/>
                  <a:ext cx="1249060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TP53INP1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6" name="图片 98" descr="图片包含 游戏机&#10;&#10;描述已自动生成">
                  <a:extLst>
                    <a:ext uri="{FF2B5EF4-FFF2-40B4-BE49-F238E27FC236}">
                      <a16:creationId xmlns:a16="http://schemas.microsoft.com/office/drawing/2014/main" id="{E8CC9081-AD67-4EE9-8CDB-0D3329FC8D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47474" t="36954" r="20712" b="58526"/>
                <a:stretch/>
              </p:blipFill>
              <p:spPr>
                <a:xfrm flipH="1">
                  <a:off x="6091823" y="2881040"/>
                  <a:ext cx="4242871" cy="35792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9" name="文本框 18">
                  <a:extLst>
                    <a:ext uri="{FF2B5EF4-FFF2-40B4-BE49-F238E27FC236}">
                      <a16:creationId xmlns:a16="http://schemas.microsoft.com/office/drawing/2014/main" id="{0361B527-F0E8-40D7-9973-D6DF89C581F6}"/>
                    </a:ext>
                  </a:extLst>
                </p:cNvPr>
                <p:cNvSpPr txBox="1"/>
                <p:nvPr/>
              </p:nvSpPr>
              <p:spPr>
                <a:xfrm rot="19172899">
                  <a:off x="8826709" y="1820832"/>
                  <a:ext cx="106024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 err="1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siCON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文本框 19">
                  <a:extLst>
                    <a:ext uri="{FF2B5EF4-FFF2-40B4-BE49-F238E27FC236}">
                      <a16:creationId xmlns:a16="http://schemas.microsoft.com/office/drawing/2014/main" id="{E37FEC6E-B35E-4F22-BED1-0C726A2EE5A4}"/>
                    </a:ext>
                  </a:extLst>
                </p:cNvPr>
                <p:cNvSpPr txBox="1"/>
                <p:nvPr/>
              </p:nvSpPr>
              <p:spPr>
                <a:xfrm rot="19172899">
                  <a:off x="9518476" y="1533267"/>
                  <a:ext cx="191913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siTLR2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矩形 15">
                  <a:extLst>
                    <a:ext uri="{FF2B5EF4-FFF2-40B4-BE49-F238E27FC236}">
                      <a16:creationId xmlns:a16="http://schemas.microsoft.com/office/drawing/2014/main" id="{1336BF87-C2D5-289D-A9C9-C552DD75F428}"/>
                    </a:ext>
                  </a:extLst>
                </p:cNvPr>
                <p:cNvSpPr/>
                <p:nvPr/>
              </p:nvSpPr>
              <p:spPr>
                <a:xfrm>
                  <a:off x="10305549" y="4378895"/>
                  <a:ext cx="556563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Flip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矩形 17">
                  <a:extLst>
                    <a:ext uri="{FF2B5EF4-FFF2-40B4-BE49-F238E27FC236}">
                      <a16:creationId xmlns:a16="http://schemas.microsoft.com/office/drawing/2014/main" id="{6BCBB114-7426-DF48-9094-768C420BC20E}"/>
                    </a:ext>
                  </a:extLst>
                </p:cNvPr>
                <p:cNvSpPr/>
                <p:nvPr/>
              </p:nvSpPr>
              <p:spPr>
                <a:xfrm>
                  <a:off x="10305549" y="3368381"/>
                  <a:ext cx="915635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Bcl2A1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矩形 22">
                  <a:extLst>
                    <a:ext uri="{FF2B5EF4-FFF2-40B4-BE49-F238E27FC236}">
                      <a16:creationId xmlns:a16="http://schemas.microsoft.com/office/drawing/2014/main" id="{31CB30B1-D01C-4864-7CC6-2D2C1147AAB5}"/>
                    </a:ext>
                  </a:extLst>
                </p:cNvPr>
                <p:cNvSpPr/>
                <p:nvPr/>
              </p:nvSpPr>
              <p:spPr>
                <a:xfrm>
                  <a:off x="10305549" y="3890332"/>
                  <a:ext cx="1120884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TNFAIP3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7" name="图片 109" descr="在地上&#10;&#10;中度可信度描述已自动生成">
                  <a:extLst>
                    <a:ext uri="{FF2B5EF4-FFF2-40B4-BE49-F238E27FC236}">
                      <a16:creationId xmlns:a16="http://schemas.microsoft.com/office/drawing/2014/main" id="{BF483D6B-4EBF-7D51-C1DA-D4F60934077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46219" t="44832" r="27545" b="51377"/>
                <a:stretch/>
              </p:blipFill>
              <p:spPr>
                <a:xfrm flipH="1">
                  <a:off x="6494931" y="3851937"/>
                  <a:ext cx="3854298" cy="35792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8" name="图片 110" descr="图片包含 游戏机&#10;&#10;描述已自动生成">
                  <a:extLst>
                    <a:ext uri="{FF2B5EF4-FFF2-40B4-BE49-F238E27FC236}">
                      <a16:creationId xmlns:a16="http://schemas.microsoft.com/office/drawing/2014/main" id="{D4DC814D-4E4B-9AD9-9410-7C2F37CB33E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42573" t="33528" r="33927" b="58723"/>
                <a:stretch/>
              </p:blipFill>
              <p:spPr>
                <a:xfrm>
                  <a:off x="8612050" y="4277711"/>
                  <a:ext cx="3530895" cy="48917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0" name="图片 112" descr="图片包含 飞行, 照片, 水, 飞机&#10;&#10;描述已自动生成">
                  <a:extLst>
                    <a:ext uri="{FF2B5EF4-FFF2-40B4-BE49-F238E27FC236}">
                      <a16:creationId xmlns:a16="http://schemas.microsoft.com/office/drawing/2014/main" id="{1A6625A2-345B-5220-6AB0-BE2EAB9889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</a:extLst>
                </a:blip>
                <a:srcRect l="41386" t="47222" r="34643" b="47700"/>
                <a:stretch/>
              </p:blipFill>
              <p:spPr>
                <a:xfrm>
                  <a:off x="8617327" y="3353251"/>
                  <a:ext cx="3683753" cy="39982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6" name="图片 32" descr="图片包含 游戏机&#10;&#10;描述已自动生成">
                  <a:extLst>
                    <a:ext uri="{FF2B5EF4-FFF2-40B4-BE49-F238E27FC236}">
                      <a16:creationId xmlns:a16="http://schemas.microsoft.com/office/drawing/2014/main" id="{E5E28C4E-AB8D-E525-CEDB-4B8B0A67DB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36999" t="65059" r="16397" b="28815"/>
                <a:stretch/>
              </p:blipFill>
              <p:spPr>
                <a:xfrm flipH="1">
                  <a:off x="8621364" y="5591944"/>
                  <a:ext cx="6453396" cy="529038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B5EB90FD-0AEC-A1BE-5CF1-ADC445505D1C}"/>
                    </a:ext>
                  </a:extLst>
                </p:cNvPr>
                <p:cNvSpPr txBox="1"/>
                <p:nvPr/>
              </p:nvSpPr>
              <p:spPr>
                <a:xfrm>
                  <a:off x="8179635" y="2869628"/>
                  <a:ext cx="55398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31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文本框 24">
                  <a:extLst>
                    <a:ext uri="{FF2B5EF4-FFF2-40B4-BE49-F238E27FC236}">
                      <a16:creationId xmlns:a16="http://schemas.microsoft.com/office/drawing/2014/main" id="{30F64BCC-5FA4-B6E2-4EC7-DD3DD8EEF817}"/>
                    </a:ext>
                  </a:extLst>
                </p:cNvPr>
                <p:cNvSpPr txBox="1"/>
                <p:nvPr/>
              </p:nvSpPr>
              <p:spPr>
                <a:xfrm>
                  <a:off x="10330530" y="5641334"/>
                  <a:ext cx="932691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Tubulin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矩形 36">
                  <a:extLst>
                    <a:ext uri="{FF2B5EF4-FFF2-40B4-BE49-F238E27FC236}">
                      <a16:creationId xmlns:a16="http://schemas.microsoft.com/office/drawing/2014/main" id="{6032AA6B-C06D-8651-8866-FC1B0E9E2D44}"/>
                    </a:ext>
                  </a:extLst>
                </p:cNvPr>
                <p:cNvSpPr/>
                <p:nvPr/>
              </p:nvSpPr>
              <p:spPr>
                <a:xfrm>
                  <a:off x="8165141" y="3408601"/>
                  <a:ext cx="441146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18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1E29E3C0-9E42-B98C-F20E-17B6ED1EEE10}"/>
                    </a:ext>
                  </a:extLst>
                </p:cNvPr>
                <p:cNvSpPr txBox="1"/>
                <p:nvPr/>
              </p:nvSpPr>
              <p:spPr>
                <a:xfrm>
                  <a:off x="8165141" y="3851936"/>
                  <a:ext cx="55398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80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FCD398F0-E864-61C9-4826-F0250AF77146}"/>
                    </a:ext>
                  </a:extLst>
                </p:cNvPr>
                <p:cNvSpPr txBox="1"/>
                <p:nvPr/>
              </p:nvSpPr>
              <p:spPr>
                <a:xfrm>
                  <a:off x="8188894" y="4414324"/>
                  <a:ext cx="55398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57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B7C02877-EAB8-1E6D-B664-7544C9B2864F}"/>
                    </a:ext>
                  </a:extLst>
                </p:cNvPr>
                <p:cNvSpPr txBox="1"/>
                <p:nvPr/>
              </p:nvSpPr>
              <p:spPr>
                <a:xfrm>
                  <a:off x="8196043" y="5695588"/>
                  <a:ext cx="55398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50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2B2C4360-A832-1F5F-1A1E-7038C9722AB2}"/>
                    </a:ext>
                  </a:extLst>
                </p:cNvPr>
                <p:cNvSpPr txBox="1"/>
                <p:nvPr/>
              </p:nvSpPr>
              <p:spPr>
                <a:xfrm>
                  <a:off x="8179635" y="2387057"/>
                  <a:ext cx="553988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kumimoji="1" lang="en-US" altLang="zh-CN" dirty="0">
                      <a:latin typeface="Arial" panose="020B0604020202020204" pitchFamily="34" charset="0"/>
                      <a:ea typeface="Microsoft YaHei" panose="020B0503020204020204" pitchFamily="34" charset="-122"/>
                      <a:cs typeface="Arial" panose="020B0604020202020204" pitchFamily="34" charset="0"/>
                    </a:rPr>
                    <a:t>31</a:t>
                  </a:r>
                  <a:endParaRPr kumimoji="1" lang="zh-CN" altLang="en-US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47" name="图片 48" descr="张着嘴&#10;&#10;低可信度描述已自动生成">
                <a:extLst>
                  <a:ext uri="{FF2B5EF4-FFF2-40B4-BE49-F238E27FC236}">
                    <a16:creationId xmlns:a16="http://schemas.microsoft.com/office/drawing/2014/main" id="{7699D75E-854E-56CC-5E2E-40810B4FD5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39272" t="30289" r="35323" b="63959"/>
              <a:stretch/>
            </p:blipFill>
            <p:spPr>
              <a:xfrm flipH="1">
                <a:off x="8638625" y="2407011"/>
                <a:ext cx="3836154" cy="4306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8" name="图片 64" descr="张着嘴&#10;&#10;低可信度描述已自动生成">
                <a:extLst>
                  <a:ext uri="{FF2B5EF4-FFF2-40B4-BE49-F238E27FC236}">
                    <a16:creationId xmlns:a16="http://schemas.microsoft.com/office/drawing/2014/main" id="{B04888F7-1CB6-5055-C625-97F941B5C4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32908" t="30320" r="40908" b="58418"/>
              <a:stretch/>
            </p:blipFill>
            <p:spPr>
              <a:xfrm flipH="1">
                <a:off x="8627585" y="4865803"/>
                <a:ext cx="3375144" cy="65719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FB20AD5-B8B7-58CC-139C-2D18E26FD6BD}"/>
                  </a:ext>
                </a:extLst>
              </p:cNvPr>
              <p:cNvSpPr txBox="1"/>
              <p:nvPr/>
            </p:nvSpPr>
            <p:spPr>
              <a:xfrm>
                <a:off x="8210193" y="4825404"/>
                <a:ext cx="553988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17</a:t>
                </a:r>
                <a:endParaRPr kumimoji="1" lang="zh-CN" altLang="en-US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AE40E37A-9733-5BE7-55FB-DA4DCEA54D57}"/>
                  </a:ext>
                </a:extLst>
              </p:cNvPr>
              <p:cNvSpPr txBox="1"/>
              <p:nvPr/>
            </p:nvSpPr>
            <p:spPr>
              <a:xfrm>
                <a:off x="8216852" y="5144824"/>
                <a:ext cx="553988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1" lang="en-US" altLang="zh-CN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19</a:t>
                </a:r>
                <a:endParaRPr kumimoji="1" lang="zh-CN" altLang="en-US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1" name="矩形 100">
                <a:extLst>
                  <a:ext uri="{FF2B5EF4-FFF2-40B4-BE49-F238E27FC236}">
                    <a16:creationId xmlns:a16="http://schemas.microsoft.com/office/drawing/2014/main" id="{24181862-9383-281A-ADE9-C462AA1D6E61}"/>
                  </a:ext>
                </a:extLst>
              </p:cNvPr>
              <p:cNvSpPr/>
              <p:nvPr/>
            </p:nvSpPr>
            <p:spPr>
              <a:xfrm>
                <a:off x="10374565" y="4935804"/>
                <a:ext cx="1415772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C-caspase3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2DBF13D2-97FD-BEB6-48C9-EEB47D89D55E}"/>
              </a:ext>
            </a:extLst>
          </p:cNvPr>
          <p:cNvSpPr/>
          <p:nvPr/>
        </p:nvSpPr>
        <p:spPr>
          <a:xfrm>
            <a:off x="5967404" y="2294551"/>
            <a:ext cx="1685632" cy="38319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94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7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 jing</dc:creator>
  <cp:lastModifiedBy>ye jing</cp:lastModifiedBy>
  <cp:revision>1</cp:revision>
  <dcterms:created xsi:type="dcterms:W3CDTF">2023-01-16T06:12:30Z</dcterms:created>
  <dcterms:modified xsi:type="dcterms:W3CDTF">2023-01-16T06:38:54Z</dcterms:modified>
</cp:coreProperties>
</file>